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1" r:id="rId3"/>
    <p:sldId id="262" r:id="rId4"/>
    <p:sldId id="263" r:id="rId5"/>
    <p:sldId id="264" r:id="rId6"/>
    <p:sldId id="258" r:id="rId7"/>
    <p:sldId id="265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98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AAB969E-6738-4556-87CA-94555B0771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B29DD2A-4697-4391-A20A-3ABAF2CA6E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1E040FD-69F0-4126-9D6B-7E0467604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DCD46EF-CAEB-4FF4-A311-D06004E29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A55B777-5CA2-4704-98C5-0C0449AFB3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976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5E0DA69-EF96-4D60-9FEF-F9F26D76D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FA06AD4-4EB1-4A5C-BF8E-2833D643D2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6531A19-D1CB-4BAA-AA67-23FDB74B5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F3915B2-B69D-4E07-ACB6-915D0EAE2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E3B0770-36F5-42F0-8632-DBADD43B7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658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83097D6A-CCED-4432-B152-8E2DFC9F6C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526A22F-D2DF-4707-8E87-332B5D9E94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996BF83-7D63-479C-8D22-73FA7C581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7BEB21E-2C70-4541-9975-D47203A2D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2DA9738-4F8A-4F7C-BB62-36B21984D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58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4D4EB30-9341-4C3D-87EF-99C0065089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A01359D-162A-4A76-848F-6AD5AC9FFC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C4AB593-0C65-408F-B21D-D2CC8A522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B963A8E-2177-4F23-8CFC-29597F7EA1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4949E39-F552-4A37-9A90-3DF5A3D32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853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F2BB603-AE9D-4319-95EE-7C6A75F5D1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A0D1A06-E4DA-4523-AF17-BD10A92107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71AE9DB-693F-420E-83CD-FD28F29CE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31855EB-AC08-472D-BFAC-58501681F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21C109F-2899-48BA-8104-2C644A7C5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275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C38E93A-9C84-4041-8FD2-04957A1546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7CD49FA-2B9D-4E96-B6B1-252370B3EF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8C30F9C-BD5D-4863-834F-360D73625C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53C3D61-6EC7-42A9-A97D-DFFE0A5AD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8480505-2367-4298-AE3A-93542CE44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A921AF5-D176-4CC5-97B0-3D5FCA37B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107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A219281-DF79-4988-AD25-4C26BAA567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D35BA6C-7083-457F-9720-39392B1332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881D19A-82A9-4485-8E4D-4C474B5B1A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D43D6B72-A60B-4269-A657-96BBF09CE7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09F69D02-0CCC-4346-A8DE-9B6126491E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2807D7EF-B9E3-4FC3-98C2-6E565CE10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CE38AC98-0A67-4920-9C28-9444A9040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0292538F-E1A2-4A36-AE77-30691278D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593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11378AD-DA7E-479B-9009-66FA0828C3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3915325-44BC-4051-A0DE-3153C2330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4CC22F2C-64F8-4DC6-AEA1-D0D234B69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BF969DFD-813B-446C-B0FA-1BAC7CE38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222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4056A644-18A2-48A9-8217-F47997FAF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6D647A4C-A726-4854-9B3C-6315B007B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2421E0E1-89B2-47AF-BF34-856AC1873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3875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3941D12-09E0-4773-A083-CE871ACC6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0D31027-1728-4F15-A450-F7AFADE229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B9FC7652-1087-4803-81AF-02A69C9A12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4A59F4D-508E-4BF9-ABC8-ED0834BF4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852BDB7-87E2-49F3-BA6D-B75681808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7700FB0-B935-45CB-A191-8D0F611D2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451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2223092-FCA6-4816-9160-62AE58B1D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F1D3C19-6920-472A-B7A2-248C22C0BE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295E5F7-9DC6-44FE-9E32-90B4A0D4E1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6A0D694-291C-4B8B-97EF-7A6B0FB19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139680A-4825-4327-857B-A3F0A8F8E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AC8DE88-D7DF-4180-8F10-9C5F6BA1C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118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A9BDC417-A722-439B-9156-AE8CB3C952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4957AEB-B5B0-49FF-A37F-1DE4CAFE83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54D3669-9693-4366-A274-79DF183FC1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ECD05-9C03-478A-AF2F-5DAE3FFBF01F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D68AAE1-169D-458C-A507-633F94840A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EDC8631-CB4D-4127-83EA-2EC9922095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F3472-713A-45A4-A138-CCEB2292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443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emf"/><Relationship Id="rId4" Type="http://schemas.openxmlformats.org/officeDocument/2006/relationships/image" Target="../media/image24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551009AC-4A0E-F942-87FE-C336481976CD}"/>
              </a:ext>
            </a:extLst>
          </p:cNvPr>
          <p:cNvSpPr txBox="1"/>
          <p:nvPr/>
        </p:nvSpPr>
        <p:spPr>
          <a:xfrm>
            <a:off x="2609088" y="2913888"/>
            <a:ext cx="63918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4099683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E7CE7072-A79A-4C07-AB93-8991DFA74F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06725" y="484752"/>
            <a:ext cx="2038350" cy="31623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DAC4A2E3-BDFD-4122-AD99-704D17CC2A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28897" y="3583875"/>
            <a:ext cx="2038350" cy="31623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77DC2696-0DFB-4765-934A-FB523DA39D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37668" y="3583875"/>
            <a:ext cx="3575050" cy="33655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E023857F-6445-4257-9223-67FB839EF15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12718" y="484752"/>
            <a:ext cx="2038350" cy="31623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B3C8D339-8BEA-40DA-B8BF-A96851EAFED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34043" y="3583875"/>
            <a:ext cx="2038350" cy="31623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45A19AE-713B-453F-B83F-9878FA11BD94}"/>
              </a:ext>
            </a:extLst>
          </p:cNvPr>
          <p:cNvSpPr txBox="1"/>
          <p:nvPr/>
        </p:nvSpPr>
        <p:spPr>
          <a:xfrm>
            <a:off x="7262867" y="96327"/>
            <a:ext cx="11608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ZR-75-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1C63A365-1886-41A4-8CE0-3926104C8DFD}"/>
              </a:ext>
            </a:extLst>
          </p:cNvPr>
          <p:cNvSpPr txBox="1"/>
          <p:nvPr/>
        </p:nvSpPr>
        <p:spPr>
          <a:xfrm>
            <a:off x="9454351" y="96326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T47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6369822F-C0AE-4820-A7D8-266121C097EE}"/>
              </a:ext>
            </a:extLst>
          </p:cNvPr>
          <p:cNvSpPr txBox="1"/>
          <p:nvPr/>
        </p:nvSpPr>
        <p:spPr>
          <a:xfrm>
            <a:off x="4662143" y="96326"/>
            <a:ext cx="9140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MCF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F97150B1-C0B3-4280-8A1E-F80D2EDAAA81}"/>
              </a:ext>
            </a:extLst>
          </p:cNvPr>
          <p:cNvSpPr txBox="1"/>
          <p:nvPr/>
        </p:nvSpPr>
        <p:spPr>
          <a:xfrm>
            <a:off x="70282" y="127103"/>
            <a:ext cx="35041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</a:t>
            </a:r>
            <a:r>
              <a:rPr lang="en-US" sz="2000" dirty="0" smtClean="0"/>
              <a:t>Figure S1 </a:t>
            </a:r>
            <a:r>
              <a:rPr lang="en-US" sz="2000" dirty="0" err="1" smtClean="0"/>
              <a:t>PartA</a:t>
            </a:r>
            <a:endParaRPr lang="en-US" sz="20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C1F27C98-A962-4A5A-9383-9D13E57B1A6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69546" y="484752"/>
            <a:ext cx="3575050" cy="336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4924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458039C0-D11E-4067-9F71-E1B73AF991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6509" y="557991"/>
            <a:ext cx="3905250" cy="33147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A7CBC3D1-0DDE-4908-9BAA-288B223F75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76509" y="3737998"/>
            <a:ext cx="3905250" cy="32956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1955563-72FF-4693-9B6C-8758155F5C75}"/>
              </a:ext>
            </a:extLst>
          </p:cNvPr>
          <p:cNvSpPr txBox="1"/>
          <p:nvPr/>
        </p:nvSpPr>
        <p:spPr>
          <a:xfrm>
            <a:off x="7154381" y="96327"/>
            <a:ext cx="11608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ZR-75-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A3B0EC30-450F-42EA-9811-CAED8E5B0848}"/>
              </a:ext>
            </a:extLst>
          </p:cNvPr>
          <p:cNvSpPr txBox="1"/>
          <p:nvPr/>
        </p:nvSpPr>
        <p:spPr>
          <a:xfrm>
            <a:off x="9345865" y="96326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T47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F546A857-2E73-4BCD-9819-A4653567D416}"/>
              </a:ext>
            </a:extLst>
          </p:cNvPr>
          <p:cNvSpPr txBox="1"/>
          <p:nvPr/>
        </p:nvSpPr>
        <p:spPr>
          <a:xfrm>
            <a:off x="4553657" y="96326"/>
            <a:ext cx="9140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MCF7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94F880A9-5588-4C3E-8E0A-9CF779B54E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44774" y="557991"/>
            <a:ext cx="2552700" cy="310515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20A7CDCF-4081-48CB-938C-49FF314BBE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16224" y="3663141"/>
            <a:ext cx="2381250" cy="30861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B1B944C-F51A-449B-95A9-AC13B0AFCEF2}"/>
              </a:ext>
            </a:extLst>
          </p:cNvPr>
          <p:cNvSpPr txBox="1"/>
          <p:nvPr/>
        </p:nvSpPr>
        <p:spPr>
          <a:xfrm>
            <a:off x="70282" y="127103"/>
            <a:ext cx="34945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</a:t>
            </a:r>
            <a:r>
              <a:rPr lang="en-US" sz="2000" dirty="0" smtClean="0"/>
              <a:t>Figure S1 </a:t>
            </a:r>
            <a:r>
              <a:rPr lang="en-US" sz="2000" dirty="0" err="1" smtClean="0"/>
              <a:t>PartB</a:t>
            </a:r>
            <a:endParaRPr lang="en-US" sz="200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88C10A56-D86D-4C49-B0BA-4E4B7939255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72642" y="3737998"/>
            <a:ext cx="2381250" cy="306705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C78D6E35-A69C-43AE-9B6D-AA91EADE492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88407" y="547115"/>
            <a:ext cx="2381250" cy="3067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40122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BB2970CE-C275-4D72-8855-F364A3835B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7837" y="789821"/>
            <a:ext cx="3873500" cy="32893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02C4C92D-175D-44DF-B425-B8F3E265A8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60057" y="778035"/>
            <a:ext cx="2559050" cy="3073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BDF8A1C4-DE39-4B47-B198-5C536C536E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94105" y="778035"/>
            <a:ext cx="2381250" cy="306705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7C59C052-EC89-4E9F-9C17-C068D61414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11965" y="3771091"/>
            <a:ext cx="2381250" cy="306705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D9D9E345-BD9A-4D18-92AC-B83F57FFE6D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79936" y="3782877"/>
            <a:ext cx="3841750" cy="329565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FF88125F-B832-4113-869E-0E2FD77B749E}"/>
              </a:ext>
            </a:extLst>
          </p:cNvPr>
          <p:cNvSpPr txBox="1"/>
          <p:nvPr/>
        </p:nvSpPr>
        <p:spPr>
          <a:xfrm>
            <a:off x="7557335" y="421792"/>
            <a:ext cx="11608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ZR-75-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024200AB-47E6-42F2-AA2C-628B3343A25B}"/>
              </a:ext>
            </a:extLst>
          </p:cNvPr>
          <p:cNvSpPr txBox="1"/>
          <p:nvPr/>
        </p:nvSpPr>
        <p:spPr>
          <a:xfrm>
            <a:off x="9748819" y="421791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T47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7700F19D-4723-4803-A74E-732DB27A9525}"/>
              </a:ext>
            </a:extLst>
          </p:cNvPr>
          <p:cNvSpPr txBox="1"/>
          <p:nvPr/>
        </p:nvSpPr>
        <p:spPr>
          <a:xfrm>
            <a:off x="4956611" y="421791"/>
            <a:ext cx="9140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MCF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8761B816-5508-4EC6-ADC9-953A166C3156}"/>
              </a:ext>
            </a:extLst>
          </p:cNvPr>
          <p:cNvSpPr txBox="1"/>
          <p:nvPr/>
        </p:nvSpPr>
        <p:spPr>
          <a:xfrm>
            <a:off x="70282" y="127103"/>
            <a:ext cx="34913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</a:t>
            </a:r>
            <a:r>
              <a:rPr lang="en-US" sz="2000" dirty="0" smtClean="0"/>
              <a:t>Figure S1 </a:t>
            </a:r>
            <a:r>
              <a:rPr lang="en-US" sz="2000" dirty="0" err="1" smtClean="0"/>
              <a:t>PartC</a:t>
            </a:r>
            <a:endParaRPr lang="en-US" sz="20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A595E4E0-433E-462C-9CBC-499EEF96F2E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37857" y="3752955"/>
            <a:ext cx="2381250" cy="307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00296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21A83F96-8D91-46A1-8A67-29B540C66F0D}"/>
              </a:ext>
            </a:extLst>
          </p:cNvPr>
          <p:cNvSpPr txBox="1"/>
          <p:nvPr/>
        </p:nvSpPr>
        <p:spPr>
          <a:xfrm>
            <a:off x="70282" y="127103"/>
            <a:ext cx="29037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</a:t>
            </a:r>
            <a:r>
              <a:rPr lang="en-US" sz="2000" dirty="0" smtClean="0"/>
              <a:t>Figure S2C</a:t>
            </a:r>
            <a:endParaRPr lang="en-US" sz="20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069CDF7B-6A98-47A2-8F04-442EBC1CC6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04991" y="1768475"/>
            <a:ext cx="2692400" cy="332105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FA982E4A-A432-49C1-B8BE-868C16C3EF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4610" y="1768475"/>
            <a:ext cx="2692400" cy="332105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1EDED1A7-E4FF-4D4A-B35F-C8C3613D09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53547" y="1768475"/>
            <a:ext cx="2692400" cy="3321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56993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795E0803-11B1-48E8-BDE2-469F11C2A9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1370" y="3755116"/>
            <a:ext cx="3117850" cy="311785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6B4830DE-317D-4148-8651-1BDBDB0F64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49220" y="3755116"/>
            <a:ext cx="3117850" cy="311785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EA824E3B-5004-49EA-9903-5A5CAD535165}"/>
              </a:ext>
            </a:extLst>
          </p:cNvPr>
          <p:cNvSpPr txBox="1"/>
          <p:nvPr/>
        </p:nvSpPr>
        <p:spPr>
          <a:xfrm>
            <a:off x="1401346" y="3792236"/>
            <a:ext cx="5454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B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B2DCE181-E52D-4E68-86D2-57125B552E1F}"/>
              </a:ext>
            </a:extLst>
          </p:cNvPr>
          <p:cNvSpPr txBox="1"/>
          <p:nvPr/>
        </p:nvSpPr>
        <p:spPr>
          <a:xfrm>
            <a:off x="194429" y="51202"/>
            <a:ext cx="27851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</a:t>
            </a:r>
            <a:r>
              <a:rPr lang="en-US" sz="2000" dirty="0" smtClean="0"/>
              <a:t>Figure S3</a:t>
            </a:r>
            <a:endParaRPr lang="en-US" sz="2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210B38A-D2C3-4F42-A6B3-208C0DF48A60}"/>
              </a:ext>
            </a:extLst>
          </p:cNvPr>
          <p:cNvSpPr txBox="1"/>
          <p:nvPr/>
        </p:nvSpPr>
        <p:spPr>
          <a:xfrm>
            <a:off x="2238598" y="511885"/>
            <a:ext cx="5629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(A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44E06C6E-52CF-4F15-AEBE-F460FFC6FD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8623" y="300197"/>
            <a:ext cx="3905250" cy="33528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9473E796-5647-2E4F-B82F-3AE7BD3354F6}"/>
              </a:ext>
            </a:extLst>
          </p:cNvPr>
          <p:cNvSpPr txBox="1"/>
          <p:nvPr/>
        </p:nvSpPr>
        <p:spPr>
          <a:xfrm>
            <a:off x="7400065" y="1284099"/>
            <a:ext cx="4451860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nsitometric quantitation graph for </a:t>
            </a: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-AMPK is shown in Suppl Fig Part A. The t-AMPK blot</a:t>
            </a: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 Fig 3A is from one of the three replicates </a:t>
            </a: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d one of the other replicate was included in Fig 1A. </a:t>
            </a: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refore, the densitometric graphs are the same as </a:t>
            </a: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ll three replicates were used for statistical analysis.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0D6EE382-0254-1F43-83F0-EB5ACAAEDBA0}"/>
              </a:ext>
            </a:extLst>
          </p:cNvPr>
          <p:cNvGrpSpPr/>
          <p:nvPr/>
        </p:nvGrpSpPr>
        <p:grpSpPr>
          <a:xfrm>
            <a:off x="8067070" y="3838402"/>
            <a:ext cx="3117850" cy="3034563"/>
            <a:chOff x="8067070" y="3838402"/>
            <a:chExt cx="3117850" cy="303456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6FC11B4B-AC18-4E1C-A6C7-B1C906472E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3384"/>
            <a:stretch/>
          </p:blipFill>
          <p:spPr>
            <a:xfrm>
              <a:off x="8067070" y="4188906"/>
              <a:ext cx="3117850" cy="2684059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CC113497-19C7-C34A-957E-754C6B2D298A}"/>
                </a:ext>
              </a:extLst>
            </p:cNvPr>
            <p:cNvSpPr txBox="1"/>
            <p:nvPr/>
          </p:nvSpPr>
          <p:spPr>
            <a:xfrm>
              <a:off x="9342403" y="3838402"/>
              <a:ext cx="10182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t-AMP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370032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xmlns="" id="{891B2C83-5157-BE49-BCC6-F0EB75DC7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7853602"/>
              </p:ext>
            </p:extLst>
          </p:nvPr>
        </p:nvGraphicFramePr>
        <p:xfrm>
          <a:off x="1535502" y="448574"/>
          <a:ext cx="9230262" cy="600398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70668">
                  <a:extLst>
                    <a:ext uri="{9D8B030D-6E8A-4147-A177-3AD203B41FA5}">
                      <a16:colId xmlns:a16="http://schemas.microsoft.com/office/drawing/2014/main" xmlns="" val="3574837994"/>
                    </a:ext>
                  </a:extLst>
                </a:gridCol>
                <a:gridCol w="3057434">
                  <a:extLst>
                    <a:ext uri="{9D8B030D-6E8A-4147-A177-3AD203B41FA5}">
                      <a16:colId xmlns:a16="http://schemas.microsoft.com/office/drawing/2014/main" xmlns="" val="3235804519"/>
                    </a:ext>
                  </a:extLst>
                </a:gridCol>
                <a:gridCol w="1260648">
                  <a:extLst>
                    <a:ext uri="{9D8B030D-6E8A-4147-A177-3AD203B41FA5}">
                      <a16:colId xmlns:a16="http://schemas.microsoft.com/office/drawing/2014/main" xmlns="" val="3518913196"/>
                    </a:ext>
                  </a:extLst>
                </a:gridCol>
                <a:gridCol w="1260648">
                  <a:extLst>
                    <a:ext uri="{9D8B030D-6E8A-4147-A177-3AD203B41FA5}">
                      <a16:colId xmlns:a16="http://schemas.microsoft.com/office/drawing/2014/main" xmlns="" val="2161638"/>
                    </a:ext>
                  </a:extLst>
                </a:gridCol>
                <a:gridCol w="1680864">
                  <a:extLst>
                    <a:ext uri="{9D8B030D-6E8A-4147-A177-3AD203B41FA5}">
                      <a16:colId xmlns:a16="http://schemas.microsoft.com/office/drawing/2014/main" xmlns="" val="3615020940"/>
                    </a:ext>
                  </a:extLst>
                </a:gridCol>
              </a:tblGrid>
              <a:tr h="42003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Table </a:t>
                      </a:r>
                      <a:r>
                        <a:rPr lang="en-US" sz="1200" u="none" strike="noStrike" dirty="0" smtClean="0">
                          <a:effectLst/>
                        </a:rPr>
                        <a:t>S1</a:t>
                      </a:r>
                      <a:r>
                        <a:rPr lang="en-US" sz="1200" u="none" strike="noStrike" dirty="0">
                          <a:effectLst/>
                        </a:rPr>
                        <a:t>. List of </a:t>
                      </a:r>
                      <a:r>
                        <a:rPr lang="en-US" sz="1200" u="none" strike="noStrike" dirty="0" smtClean="0">
                          <a:effectLst/>
                        </a:rPr>
                        <a:t>Antibodies.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53149356"/>
                  </a:ext>
                </a:extLst>
              </a:tr>
              <a:tr h="4200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ntibody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ompany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atalog#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echniqu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Dilution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4050222641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MPK⍺1/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anta Cruz Biotechnolog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c-744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L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1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151232099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MPK⍺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ell Signaling Technolog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5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20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3097344198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hospho-AMPK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ell Signaling Technolog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5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10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3680283470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l-GR" sz="1200" u="none" strike="noStrike" dirty="0">
                          <a:effectLst/>
                        </a:rPr>
                        <a:t>β-</a:t>
                      </a:r>
                      <a:r>
                        <a:rPr lang="en-US" sz="1200" u="none" strike="noStrike" dirty="0">
                          <a:effectLst/>
                        </a:rPr>
                        <a:t>act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anta Cruz Biotechnolog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c-477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10,0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74555860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ER⍺-F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anta Cruz Biotechnolog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c-80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2500-1:50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84134993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ER⍺-D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anta Cruz Biotechnolog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c-80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20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208892612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ER⍺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R&amp;D System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MAB5715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25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924876000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ER⍺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R&amp;D System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MAB5715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L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2473268946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53-DO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Santa Cruz Biotechnolog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sc-1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2500-1:50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485972608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53-DO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Santa Cruz Biotechnolog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sc-1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L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1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2618853157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53-FL39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anta Cruz Biotechnolog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c-62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L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:1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2981168760"/>
                  </a:ext>
                </a:extLst>
              </a:tr>
              <a:tr h="395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70s6k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ell Signaling Technolog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92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 W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:20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3695834828"/>
                  </a:ext>
                </a:extLst>
              </a:tr>
              <a:tr h="42003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hospho-p70s6k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ell Signaling Technolog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92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:20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41239474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081459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90</TotalTime>
  <Words>205</Words>
  <Application>Microsoft Office PowerPoint</Application>
  <PresentationFormat>Widescreen</PresentationFormat>
  <Paragraphs>9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ndhi, Nishant</dc:creator>
  <cp:lastModifiedBy>MDPI</cp:lastModifiedBy>
  <cp:revision>67</cp:revision>
  <dcterms:created xsi:type="dcterms:W3CDTF">2021-06-11T22:41:55Z</dcterms:created>
  <dcterms:modified xsi:type="dcterms:W3CDTF">2021-07-22T03:00:13Z</dcterms:modified>
</cp:coreProperties>
</file>